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5"/>
  </p:notesMasterIdLst>
  <p:handoutMasterIdLst>
    <p:handoutMasterId r:id="rId16"/>
  </p:handoutMasterIdLst>
  <p:sldIdLst>
    <p:sldId id="260" r:id="rId6"/>
    <p:sldId id="262" r:id="rId7"/>
    <p:sldId id="263" r:id="rId8"/>
    <p:sldId id="264" r:id="rId9"/>
    <p:sldId id="265" r:id="rId10"/>
    <p:sldId id="266" r:id="rId11"/>
    <p:sldId id="267" r:id="rId12"/>
    <p:sldId id="269" r:id="rId13"/>
    <p:sldId id="270" r:id="rId14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84" y="57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handoutMaster" Target="handoutMasters/handout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5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23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23/07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 smtClean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 smtClean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 smtClean="0"/>
              <a:t>Month and year of presentation (e.g. ‘October 2017’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 smtClean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timing>
    <p:tnLst>
      <p:par>
        <p:cTn id="1" dur="indefinite" restart="never" nodeType="tmRoot"/>
      </p:par>
    </p:tnLst>
  </p:timing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6" y="3507854"/>
            <a:ext cx="6359382" cy="360040"/>
          </a:xfrm>
        </p:spPr>
        <p:txBody>
          <a:bodyPr>
            <a:normAutofit fontScale="90000"/>
          </a:bodyPr>
          <a:lstStyle/>
          <a:p>
            <a:r>
              <a:rPr lang="en-GB" dirty="0" smtClean="0"/>
              <a:t>LIFELONG RECURRENT TAKOTSUBO CARDIOMYOPATHY – A CASE REPORT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GB" dirty="0" err="1"/>
              <a:t>Ms.</a:t>
            </a:r>
            <a:r>
              <a:rPr lang="en-GB" dirty="0"/>
              <a:t> No. EHJ-CR-D-19-00272 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 smtClean="0"/>
              <a:t>July 201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Introduct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</a:t>
            </a:r>
            <a:r>
              <a:rPr lang="en-GB" dirty="0"/>
              <a:t>Reference</a:t>
            </a:r>
          </a:p>
          <a:p>
            <a:r>
              <a:rPr lang="en-GB" dirty="0" smtClean="0"/>
              <a:t> </a:t>
            </a:r>
            <a:r>
              <a:rPr lang="en-GB" dirty="0" err="1" smtClean="0"/>
              <a:t>Ms</a:t>
            </a:r>
            <a:r>
              <a:rPr lang="en-GB" dirty="0" err="1"/>
              <a:t>.</a:t>
            </a:r>
            <a:r>
              <a:rPr lang="en-GB" dirty="0"/>
              <a:t> No. EHJ-CR-D-19-00272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539502" y="1195011"/>
            <a:ext cx="7632898" cy="34776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err="1"/>
              <a:t>Takotsubo</a:t>
            </a:r>
            <a:r>
              <a:rPr lang="en-GB" b="0" dirty="0"/>
              <a:t> Cardiomyopathy is a transient left ventricular dysfunction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Has </a:t>
            </a:r>
            <a:r>
              <a:rPr lang="en-GB" b="0" dirty="0" smtClean="0"/>
              <a:t>an established </a:t>
            </a:r>
            <a:r>
              <a:rPr lang="en-GB" b="0" dirty="0"/>
              <a:t>recognised recurrence </a:t>
            </a:r>
            <a:r>
              <a:rPr lang="en-GB" b="0" dirty="0" smtClean="0"/>
              <a:t>rate in populations. </a:t>
            </a:r>
            <a:endParaRPr lang="en-GB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err="1" smtClean="0"/>
              <a:t>Takotsubo</a:t>
            </a:r>
            <a:r>
              <a:rPr lang="en-GB" b="0" dirty="0" smtClean="0"/>
              <a:t> Cardiomyopathy mimics acute myocardial infarction in its presentation, hence it is important for clinicians to be able to distinguish between these two entities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</a:t>
            </a:r>
            <a:r>
              <a:rPr lang="en-GB" dirty="0"/>
              <a:t>Reference </a:t>
            </a:r>
            <a:r>
              <a:rPr lang="en-GB" dirty="0" smtClean="0"/>
              <a:t> </a:t>
            </a:r>
            <a:r>
              <a:rPr lang="en-GB" dirty="0" err="1" smtClean="0"/>
              <a:t>Ms</a:t>
            </a:r>
            <a:r>
              <a:rPr lang="en-GB" dirty="0" err="1"/>
              <a:t>.</a:t>
            </a:r>
            <a:r>
              <a:rPr lang="en-GB" dirty="0"/>
              <a:t> No. EHJ-CR-D-19-00272 </a:t>
            </a:r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266330" y="1224000"/>
            <a:ext cx="7834062" cy="31680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smtClean="0"/>
              <a:t>76 year old lady presented to Aberdeen Royal Infirmary in 2014 with central chest pain in the context of a recent bereavement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smtClean="0"/>
              <a:t>Physical examinations were unremarkable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smtClean="0"/>
              <a:t>Past medical history include 3 previous myocardial infarctions in 1986,1988 and 1998, </a:t>
            </a:r>
            <a:r>
              <a:rPr lang="en-GB" b="0" dirty="0" err="1" smtClean="0"/>
              <a:t>hypercholesterolaemia</a:t>
            </a:r>
            <a:r>
              <a:rPr lang="en-GB" b="0" dirty="0" smtClean="0"/>
              <a:t> and is an ex-smoker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smtClean="0"/>
              <a:t>Significant family history of ischaemic heart disease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smtClean="0"/>
              <a:t> She represented again with similar episodes of chest pain in 2015 and 2018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</a:t>
            </a:r>
            <a:r>
              <a:rPr lang="en-GB" dirty="0"/>
              <a:t>Reference </a:t>
            </a:r>
            <a:r>
              <a:rPr lang="en-GB" dirty="0" err="1"/>
              <a:t>Ms.</a:t>
            </a:r>
            <a:r>
              <a:rPr lang="en-GB" dirty="0"/>
              <a:t> No. EHJ-CR-D-19-00272 </a:t>
            </a:r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239697" y="1224000"/>
            <a:ext cx="4225771" cy="3241468"/>
          </a:xfrm>
          <a:ln>
            <a:solidFill>
              <a:srgbClr val="FF0066"/>
            </a:solidFill>
          </a:ln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endParaRPr lang="en-GB" sz="1600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b="0" dirty="0" smtClean="0"/>
              <a:t>Historic ECGs in </a:t>
            </a:r>
            <a:r>
              <a:rPr lang="en-GB" sz="1600" dirty="0" smtClean="0">
                <a:solidFill>
                  <a:srgbClr val="FF0000"/>
                </a:solidFill>
              </a:rPr>
              <a:t>1986, 1988 and 1998 </a:t>
            </a:r>
            <a:r>
              <a:rPr lang="en-GB" sz="1600" b="0" dirty="0" smtClean="0"/>
              <a:t>showing widespread T wave inversion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b="0" dirty="0" err="1" smtClean="0"/>
              <a:t>Creatine</a:t>
            </a:r>
            <a:r>
              <a:rPr lang="en-GB" sz="1600" b="0" dirty="0" smtClean="0"/>
              <a:t> kinase (CK)  were unremarkable in 1986 and 1988. In 1998, CK was raised. Coronary angiogram in 1998 were unremarkable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b="0" dirty="0"/>
              <a:t>In </a:t>
            </a:r>
            <a:r>
              <a:rPr lang="en-GB" sz="1600" dirty="0">
                <a:solidFill>
                  <a:srgbClr val="FF0000"/>
                </a:solidFill>
              </a:rPr>
              <a:t>2014</a:t>
            </a:r>
            <a:r>
              <a:rPr lang="en-GB" sz="1600" b="0" dirty="0"/>
              <a:t>, ECG </a:t>
            </a:r>
            <a:r>
              <a:rPr lang="en-GB" sz="1600" b="0" dirty="0" smtClean="0"/>
              <a:t>showed </a:t>
            </a:r>
            <a:r>
              <a:rPr lang="en-GB" sz="1600" b="0" dirty="0" err="1"/>
              <a:t>hyperacute</a:t>
            </a:r>
            <a:r>
              <a:rPr lang="en-GB" sz="1600" b="0" dirty="0"/>
              <a:t> T waves, raised cardiac markers, apical ballooning in ECHO image, normal coronary angiogram, extensive apical ballooning in </a:t>
            </a:r>
            <a:r>
              <a:rPr lang="en-GB" sz="1600" b="0" dirty="0" err="1"/>
              <a:t>Lvgram</a:t>
            </a:r>
            <a:r>
              <a:rPr lang="en-GB" sz="1600" b="0" dirty="0"/>
              <a:t> and CMR ruled out myocardial infarction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600" b="0" dirty="0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4589755" y="1224000"/>
            <a:ext cx="3781887" cy="3241468"/>
          </a:xfrm>
          <a:ln>
            <a:solidFill>
              <a:srgbClr val="FF0066"/>
            </a:solidFill>
          </a:ln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endParaRPr lang="en-GB" sz="1600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b="0" dirty="0" smtClean="0"/>
              <a:t>In </a:t>
            </a:r>
            <a:r>
              <a:rPr lang="en-GB" sz="1600" dirty="0" smtClean="0">
                <a:solidFill>
                  <a:srgbClr val="FF0000"/>
                </a:solidFill>
              </a:rPr>
              <a:t>2015</a:t>
            </a:r>
            <a:r>
              <a:rPr lang="en-GB" sz="1600" b="0" dirty="0" smtClean="0"/>
              <a:t>, ECG showed </a:t>
            </a:r>
            <a:r>
              <a:rPr lang="en-GB" sz="1600" b="0" dirty="0" err="1" smtClean="0"/>
              <a:t>hyperacute</a:t>
            </a:r>
            <a:r>
              <a:rPr lang="en-GB" sz="1600" b="0" dirty="0" smtClean="0"/>
              <a:t> T waves, </a:t>
            </a:r>
            <a:r>
              <a:rPr lang="en-GB" sz="1600" b="0" dirty="0" err="1" smtClean="0"/>
              <a:t>QTc</a:t>
            </a:r>
            <a:r>
              <a:rPr lang="en-GB" sz="1600" b="0" dirty="0" smtClean="0"/>
              <a:t> 560ms. Raised cardiac enzymes. Normal coronary arteries. LV gram showed mild </a:t>
            </a:r>
            <a:r>
              <a:rPr lang="en-GB" sz="1600" b="0" dirty="0" err="1" smtClean="0"/>
              <a:t>hypokinesis</a:t>
            </a:r>
            <a:r>
              <a:rPr lang="en-GB" sz="1600" b="0" dirty="0" smtClean="0"/>
              <a:t> in the inferior </a:t>
            </a:r>
            <a:r>
              <a:rPr lang="en-GB" sz="1600" b="0" dirty="0" smtClean="0"/>
              <a:t>apical wall</a:t>
            </a:r>
            <a:r>
              <a:rPr lang="en-GB" sz="1600" b="0" dirty="0" smtClean="0"/>
              <a:t>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600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b="0" dirty="0" smtClean="0"/>
              <a:t>In </a:t>
            </a:r>
            <a:r>
              <a:rPr lang="en-GB" sz="1600" dirty="0" smtClean="0">
                <a:solidFill>
                  <a:srgbClr val="FF0000"/>
                </a:solidFill>
              </a:rPr>
              <a:t>2018</a:t>
            </a:r>
            <a:r>
              <a:rPr lang="en-GB" sz="1600" b="0" dirty="0" smtClean="0"/>
              <a:t>, ECG showed widespread T wave inversion and </a:t>
            </a:r>
            <a:r>
              <a:rPr lang="en-GB" sz="1600" b="0" dirty="0" err="1" smtClean="0"/>
              <a:t>QTc</a:t>
            </a:r>
            <a:r>
              <a:rPr lang="en-GB" sz="1600" b="0" dirty="0" smtClean="0"/>
              <a:t> 527ms. Raised cardiac enzymes. Angiogram showed normal coronary arteries once again. CMR showed focal phenotype of </a:t>
            </a:r>
            <a:r>
              <a:rPr lang="en-GB" sz="1600" b="0" dirty="0" err="1" smtClean="0"/>
              <a:t>Takotsubo</a:t>
            </a:r>
            <a:r>
              <a:rPr lang="en-GB" sz="1600" b="0" dirty="0" smtClean="0"/>
              <a:t>.</a:t>
            </a:r>
            <a:endParaRPr lang="en-GB" sz="1600" b="0" dirty="0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</a:t>
            </a:r>
            <a:r>
              <a:rPr lang="en-GB" dirty="0"/>
              <a:t>Reference </a:t>
            </a:r>
            <a:r>
              <a:rPr lang="en-GB" dirty="0" err="1"/>
              <a:t>Ms.</a:t>
            </a:r>
            <a:r>
              <a:rPr lang="en-GB" dirty="0"/>
              <a:t> No. EHJ-CR-D-19-00272 </a:t>
            </a:r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/>
          <a:lstStyle/>
          <a:p>
            <a:endParaRPr lang="en-GB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smtClean="0"/>
              <a:t>Patient made good recovery after each episode of </a:t>
            </a:r>
            <a:r>
              <a:rPr lang="en-GB" b="0" dirty="0" err="1" smtClean="0"/>
              <a:t>Takotsubo</a:t>
            </a:r>
            <a:r>
              <a:rPr lang="en-GB" b="0" dirty="0" smtClean="0"/>
              <a:t>, achieving normal left ventricular ejection fraction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smtClean="0"/>
              <a:t>Regular follow up in the outpatient </a:t>
            </a:r>
            <a:r>
              <a:rPr lang="en-GB" b="0" dirty="0" err="1" smtClean="0"/>
              <a:t>Takotsubo</a:t>
            </a:r>
            <a:r>
              <a:rPr lang="en-GB" b="0" dirty="0" smtClean="0"/>
              <a:t> Clinic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smtClean="0"/>
              <a:t>She is currently managed with Furosemide, </a:t>
            </a:r>
            <a:r>
              <a:rPr lang="en-GB" b="0" dirty="0" err="1" smtClean="0"/>
              <a:t>Ramipril</a:t>
            </a:r>
            <a:r>
              <a:rPr lang="en-GB" b="0" dirty="0" smtClean="0"/>
              <a:t> and Atorvastatin. </a:t>
            </a:r>
            <a:endParaRPr lang="en-GB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Discussion</a:t>
            </a:r>
            <a:br>
              <a:rPr lang="en-GB" sz="3600" b="0" dirty="0" smtClean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</a:t>
            </a:r>
            <a:r>
              <a:rPr lang="en-GB" dirty="0"/>
              <a:t>Reference </a:t>
            </a:r>
            <a:r>
              <a:rPr lang="en-GB" dirty="0" err="1"/>
              <a:t>Ms.</a:t>
            </a:r>
            <a:r>
              <a:rPr lang="en-GB" dirty="0"/>
              <a:t> No. EHJ-CR-D-19-00272 </a:t>
            </a:r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6724940" cy="3168000"/>
          </a:xfrm>
        </p:spPr>
        <p:txBody>
          <a:bodyPr/>
          <a:lstStyle/>
          <a:p>
            <a:endParaRPr lang="en-GB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</p:txBody>
      </p:sp>
      <p:sp>
        <p:nvSpPr>
          <p:cNvPr id="7" name="TextBox 6"/>
          <p:cNvSpPr txBox="1"/>
          <p:nvPr/>
        </p:nvSpPr>
        <p:spPr>
          <a:xfrm>
            <a:off x="763480" y="1313895"/>
            <a:ext cx="7137646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 smtClean="0"/>
              <a:t>This is 3 confirmed cases of recurrences of </a:t>
            </a:r>
            <a:r>
              <a:rPr lang="en-GB" dirty="0" err="1" smtClean="0"/>
              <a:t>Takotsubo</a:t>
            </a:r>
            <a:r>
              <a:rPr lang="en-GB" dirty="0" smtClean="0"/>
              <a:t> Cardiomyopathy, in the background of another 3 previous admissions at the same institution which most likely represented </a:t>
            </a:r>
            <a:r>
              <a:rPr lang="en-GB" dirty="0" err="1" smtClean="0"/>
              <a:t>Takotsubo</a:t>
            </a:r>
            <a:r>
              <a:rPr lang="en-GB" dirty="0" smtClean="0"/>
              <a:t>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GB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 err="1" smtClean="0"/>
              <a:t>Takotsubo</a:t>
            </a:r>
            <a:r>
              <a:rPr lang="en-GB" dirty="0" smtClean="0"/>
              <a:t> was only discovered in 1991, hence the episodes in 1986 and 1988 was most likely mislabelled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GB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 smtClean="0"/>
              <a:t>Due to historic limitations with the lack of CMR and non specific cardiac enzyme markers, the diagnosis of </a:t>
            </a:r>
            <a:r>
              <a:rPr lang="en-GB" dirty="0" err="1" smtClean="0"/>
              <a:t>Takotsubo</a:t>
            </a:r>
            <a:r>
              <a:rPr lang="en-GB" dirty="0" smtClean="0"/>
              <a:t> was unable to be made in 1998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GB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Discuss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</a:t>
            </a:r>
            <a:r>
              <a:rPr lang="en-GB" dirty="0"/>
              <a:t>Reference </a:t>
            </a:r>
            <a:r>
              <a:rPr lang="en-GB" dirty="0" err="1"/>
              <a:t>Ms.</a:t>
            </a:r>
            <a:r>
              <a:rPr lang="en-GB" dirty="0"/>
              <a:t> No. EHJ-CR-D-19-00272 </a:t>
            </a:r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145219"/>
            <a:ext cx="7128392" cy="3246781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 err="1" smtClean="0"/>
              <a:t>InterTak</a:t>
            </a:r>
            <a:r>
              <a:rPr lang="en-GB" sz="1800" b="0" dirty="0" smtClean="0"/>
              <a:t> Diagnostic Score and Probability was calculated  retrospectively in each episode to help distinguish between Acute </a:t>
            </a:r>
            <a:r>
              <a:rPr lang="en-GB" sz="1800" b="0" dirty="0"/>
              <a:t>C</a:t>
            </a:r>
            <a:r>
              <a:rPr lang="en-GB" sz="1800" b="0" dirty="0" smtClean="0"/>
              <a:t>oronary </a:t>
            </a:r>
            <a:r>
              <a:rPr lang="en-GB" sz="1800" b="0" dirty="0"/>
              <a:t>S</a:t>
            </a:r>
            <a:r>
              <a:rPr lang="en-GB" sz="1800" b="0" dirty="0" smtClean="0"/>
              <a:t>yndrome and </a:t>
            </a:r>
            <a:r>
              <a:rPr lang="en-GB" sz="1800" b="0" dirty="0" err="1" smtClean="0"/>
              <a:t>Takotsubo</a:t>
            </a:r>
            <a:r>
              <a:rPr lang="en-GB" sz="1800" b="0" dirty="0" smtClean="0"/>
              <a:t> Cardiomyopathy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b="0" dirty="0" smtClean="0"/>
              <a:t>Patient demonstrated at least 3 different left ventricular morphological types </a:t>
            </a:r>
            <a:r>
              <a:rPr lang="en-GB" sz="1800" b="0" dirty="0" err="1" smtClean="0"/>
              <a:t>i.e</a:t>
            </a:r>
            <a:r>
              <a:rPr lang="en-GB" sz="1800" b="0" dirty="0" smtClean="0"/>
              <a:t> focal, mid-cavity and apical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Learning Points</a:t>
            </a:r>
            <a:endParaRPr lang="en-GB" sz="320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</a:t>
            </a:r>
            <a:r>
              <a:rPr lang="en-GB" dirty="0"/>
              <a:t>Reference </a:t>
            </a:r>
            <a:r>
              <a:rPr lang="en-GB" dirty="0" err="1"/>
              <a:t>Ms.</a:t>
            </a:r>
            <a:r>
              <a:rPr lang="en-GB" dirty="0"/>
              <a:t> No. EHJ-CR-D-19-00272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539552" y="1240094"/>
            <a:ext cx="2656409" cy="3047819"/>
          </a:xfrm>
        </p:spPr>
        <p:txBody>
          <a:bodyPr/>
          <a:lstStyle/>
          <a:p>
            <a:endParaRPr lang="en-GB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smtClean="0"/>
              <a:t>Awareness about multiple recurrences of </a:t>
            </a:r>
            <a:r>
              <a:rPr lang="en-GB" b="0" dirty="0" err="1" smtClean="0"/>
              <a:t>Takotsubo</a:t>
            </a:r>
            <a:r>
              <a:rPr lang="en-GB" b="0" dirty="0" smtClean="0"/>
              <a:t> within the same individual and shifting morphological variants. </a:t>
            </a:r>
            <a:endParaRPr lang="en-GB" b="0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3373306" y="1240094"/>
            <a:ext cx="2397388" cy="3047819"/>
          </a:xfrm>
        </p:spPr>
        <p:txBody>
          <a:bodyPr/>
          <a:lstStyle/>
          <a:p>
            <a:endParaRPr lang="en-GB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smtClean="0"/>
              <a:t>The importance of distinguishing between acute myocardial infarction and </a:t>
            </a:r>
            <a:r>
              <a:rPr lang="en-GB" b="0" dirty="0" err="1" smtClean="0"/>
              <a:t>Takotsubo</a:t>
            </a:r>
            <a:r>
              <a:rPr lang="en-GB" b="0" dirty="0" smtClean="0"/>
              <a:t> Cardiomyopathy. </a:t>
            </a:r>
            <a:endParaRPr lang="en-GB" b="0" dirty="0"/>
          </a:p>
        </p:txBody>
      </p:sp>
      <p:sp>
        <p:nvSpPr>
          <p:cNvPr id="13" name="TextBox 12"/>
          <p:cNvSpPr txBox="1"/>
          <p:nvPr/>
        </p:nvSpPr>
        <p:spPr>
          <a:xfrm>
            <a:off x="5921406" y="1606858"/>
            <a:ext cx="243248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 smtClean="0"/>
              <a:t>The need for more multicentre prospective clinical trials and registries of </a:t>
            </a:r>
            <a:r>
              <a:rPr lang="en-GB" sz="2000" dirty="0" err="1" smtClean="0"/>
              <a:t>Takotsubo</a:t>
            </a:r>
            <a:r>
              <a:rPr lang="en-GB" sz="2000" dirty="0" smtClean="0"/>
              <a:t>. </a:t>
            </a: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References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</a:t>
            </a:r>
            <a:r>
              <a:rPr lang="en-GB" dirty="0"/>
              <a:t>Reference   </a:t>
            </a:r>
            <a:r>
              <a:rPr lang="en-GB" dirty="0" err="1"/>
              <a:t>Ms.</a:t>
            </a:r>
            <a:r>
              <a:rPr lang="en-GB" dirty="0"/>
              <a:t> No. EHJ-CR-D-19-00272 </a:t>
            </a:r>
          </a:p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6" name="Rectangle 1"/>
          <p:cNvSpPr>
            <a:spLocks noGrp="1" noChangeArrowheads="1"/>
          </p:cNvSpPr>
          <p:nvPr>
            <p:ph sz="quarter" idx="13"/>
          </p:nvPr>
        </p:nvSpPr>
        <p:spPr bwMode="auto">
          <a:xfrm>
            <a:off x="387151" y="733652"/>
            <a:ext cx="7561827" cy="4339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</a:t>
            </a:r>
            <a:endParaRPr lang="en-GB" sz="1200" b="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Scott </a:t>
            </a:r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W. Sharkey, Denise C. </a:t>
            </a:r>
            <a:r>
              <a:rPr lang="en-GB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Windenburg</a:t>
            </a:r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 , John R. Lesser, Martin S. </a:t>
            </a:r>
            <a:r>
              <a:rPr lang="en-GB" sz="1200" b="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on</a:t>
            </a: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, Robert G. Hauser, Jennifer N. </a:t>
            </a:r>
            <a:endParaRPr lang="en-GB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     Lesser </a:t>
            </a:r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et al. Natural history and </a:t>
            </a: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Expansive Clinical Profile of Stress (</a:t>
            </a:r>
            <a:r>
              <a:rPr lang="en-GB" sz="1200" b="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ko-Tsubo</a:t>
            </a: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) Cardiomyopathy. JACC</a:t>
            </a:r>
            <a:endParaRPr lang="en-GB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     2010; 55:333-341</a:t>
            </a:r>
          </a:p>
          <a:p>
            <a:endParaRPr lang="en-GB" sz="1200" b="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Elesber</a:t>
            </a:r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 AA, Prasad A, Lennon RJ, Wright RS, </a:t>
            </a:r>
            <a:r>
              <a:rPr lang="en-GB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Lerman</a:t>
            </a:r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 A, </a:t>
            </a:r>
            <a:r>
              <a:rPr lang="en-GB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Rihal</a:t>
            </a:r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 CS. </a:t>
            </a: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Four-Year </a:t>
            </a:r>
            <a:r>
              <a:rPr lang="en-GB" sz="12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currence Rate </a:t>
            </a:r>
            <a:r>
              <a:rPr lang="en-GB" sz="1200" b="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   Prognosis of the Apical Ballooning Syndrome. JACC 2007; 50: 448-452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endParaRPr lang="en-GB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endParaRPr lang="en-GB" sz="1200" b="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b="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hadri</a:t>
            </a:r>
            <a:r>
              <a:rPr lang="en-GB" sz="12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JR, </a:t>
            </a:r>
            <a:r>
              <a:rPr lang="en-GB" sz="1200" b="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mmann</a:t>
            </a:r>
            <a:r>
              <a:rPr lang="en-GB" sz="12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L, </a:t>
            </a:r>
            <a:r>
              <a:rPr lang="en-GB" sz="1200" b="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Jurisic</a:t>
            </a:r>
            <a:r>
              <a:rPr lang="en-GB" sz="12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, Seifert B, </a:t>
            </a:r>
            <a:r>
              <a:rPr lang="en-GB" sz="1200" b="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app</a:t>
            </a:r>
            <a:r>
              <a:rPr lang="en-GB" sz="12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LC, </a:t>
            </a:r>
            <a:r>
              <a:rPr lang="en-GB" sz="1200" b="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iekmann</a:t>
            </a:r>
            <a:r>
              <a:rPr lang="en-GB" sz="12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J et al.  A </a:t>
            </a:r>
            <a:r>
              <a:rPr lang="en-GB" sz="1200" b="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ovel Clinical Score (</a:t>
            </a:r>
            <a:r>
              <a:rPr lang="en-GB" sz="1200" b="0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terTak</a:t>
            </a:r>
            <a:r>
              <a:rPr lang="en-GB" sz="1200" b="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GB" sz="1200" b="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b="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   Diagnostic </a:t>
            </a:r>
            <a:r>
              <a:rPr lang="en-US" sz="12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ore) to Differentiate </a:t>
            </a:r>
            <a:r>
              <a:rPr lang="en-US" sz="1200" b="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akotsubo</a:t>
            </a:r>
            <a:r>
              <a:rPr lang="en-US" sz="12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yndrome </a:t>
            </a:r>
            <a:r>
              <a:rPr lang="en-US" sz="1200" b="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rom acute coronary syndrome : results from the </a:t>
            </a:r>
            <a:endParaRPr lang="en-GB" sz="1200" b="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  International </a:t>
            </a:r>
            <a:r>
              <a:rPr lang="en-US" sz="1200" b="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akotsubo</a:t>
            </a:r>
            <a:r>
              <a:rPr lang="en-US" sz="12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egistry. </a:t>
            </a:r>
            <a:r>
              <a:rPr lang="en-US" sz="1200" b="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uropean Journal of Heart Failure December 2016; 19:1036 -1042</a:t>
            </a:r>
            <a:endParaRPr lang="en-GB" sz="1200" b="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b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GB" sz="1200" b="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4.</a:t>
            </a:r>
            <a:r>
              <a:rPr lang="en-GB" sz="1200" dirty="0"/>
              <a:t>  </a:t>
            </a:r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Sato H, </a:t>
            </a:r>
            <a:r>
              <a:rPr lang="en-GB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Tateishi</a:t>
            </a:r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 H, Uchida T, Dote K, Ishihara M, Kodama K, et al. Clinical aspect </a:t>
            </a: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of myocardial injury: </a:t>
            </a:r>
            <a:endParaRPr lang="en-GB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     from </a:t>
            </a:r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ischemia to heart failure. Kagaku </a:t>
            </a:r>
            <a:r>
              <a:rPr lang="en-GB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Hyoronsha</a:t>
            </a:r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1990:55-64</a:t>
            </a:r>
            <a:endParaRPr lang="en-GB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  <a:endParaRPr lang="en-GB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endParaRPr lang="en-GB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200" b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b="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endParaRPr kumimoji="0" lang="en-GB" sz="1800" b="0" i="0" strike="noStrike" cap="none" normalizeH="0" baseline="0" dirty="0" smtClean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6</TotalTime>
  <Words>732</Words>
  <Application>Microsoft Office PowerPoint</Application>
  <PresentationFormat>On-screen Show (16:9)</PresentationFormat>
  <Paragraphs>86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5</vt:i4>
      </vt:variant>
      <vt:variant>
        <vt:lpstr>Slide Titles</vt:lpstr>
      </vt:variant>
      <vt:variant>
        <vt:i4>9</vt:i4>
      </vt:variant>
    </vt:vector>
  </HeadingPairs>
  <TitlesOfParts>
    <vt:vector size="17" baseType="lpstr">
      <vt:lpstr>Arial</vt:lpstr>
      <vt:lpstr>Calibri</vt:lpstr>
      <vt:lpstr>Times New Roman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LIFELONG RECURRENT TAKOTSUBO CARDIOMYOPATHY – A CASE REPORT</vt:lpstr>
      <vt:lpstr>Introduction</vt:lpstr>
      <vt:lpstr>Case Presentation History and Examination Findings</vt:lpstr>
      <vt:lpstr>Case Presentation Investigations</vt:lpstr>
      <vt:lpstr>Case Presentation Management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Shekinah KM Chandy</cp:lastModifiedBy>
  <cp:revision>62</cp:revision>
  <dcterms:created xsi:type="dcterms:W3CDTF">2017-10-02T09:19:02Z</dcterms:created>
  <dcterms:modified xsi:type="dcterms:W3CDTF">2019-07-23T15:55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